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48" d="100"/>
          <a:sy n="48" d="100"/>
        </p:scale>
        <p:origin x="2128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1D89C-4773-4A0C-99F9-F29AA1628430}" type="datetimeFigureOut">
              <a:rPr lang="en-US" smtClean="0"/>
              <a:t>12/1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ED02A2-DBF3-43CE-9BE3-A24CFF2C8C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95458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1D89C-4773-4A0C-99F9-F29AA1628430}" type="datetimeFigureOut">
              <a:rPr lang="en-US" smtClean="0"/>
              <a:t>12/1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ED02A2-DBF3-43CE-9BE3-A24CFF2C8C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01437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1D89C-4773-4A0C-99F9-F29AA1628430}" type="datetimeFigureOut">
              <a:rPr lang="en-US" smtClean="0"/>
              <a:t>12/1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ED02A2-DBF3-43CE-9BE3-A24CFF2C8C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21295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1D89C-4773-4A0C-99F9-F29AA1628430}" type="datetimeFigureOut">
              <a:rPr lang="en-US" smtClean="0"/>
              <a:t>12/1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ED02A2-DBF3-43CE-9BE3-A24CFF2C8C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92422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1D89C-4773-4A0C-99F9-F29AA1628430}" type="datetimeFigureOut">
              <a:rPr lang="en-US" smtClean="0"/>
              <a:t>12/1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ED02A2-DBF3-43CE-9BE3-A24CFF2C8C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05570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1D89C-4773-4A0C-99F9-F29AA1628430}" type="datetimeFigureOut">
              <a:rPr lang="en-US" smtClean="0"/>
              <a:t>12/1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ED02A2-DBF3-43CE-9BE3-A24CFF2C8C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51058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1D89C-4773-4A0C-99F9-F29AA1628430}" type="datetimeFigureOut">
              <a:rPr lang="en-US" smtClean="0"/>
              <a:t>12/13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ED02A2-DBF3-43CE-9BE3-A24CFF2C8C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76350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1D89C-4773-4A0C-99F9-F29AA1628430}" type="datetimeFigureOut">
              <a:rPr lang="en-US" smtClean="0"/>
              <a:t>12/13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ED02A2-DBF3-43CE-9BE3-A24CFF2C8C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58628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1D89C-4773-4A0C-99F9-F29AA1628430}" type="datetimeFigureOut">
              <a:rPr lang="en-US" smtClean="0"/>
              <a:t>12/13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ED02A2-DBF3-43CE-9BE3-A24CFF2C8C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54319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1D89C-4773-4A0C-99F9-F29AA1628430}" type="datetimeFigureOut">
              <a:rPr lang="en-US" smtClean="0"/>
              <a:t>12/1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ED02A2-DBF3-43CE-9BE3-A24CFF2C8C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11290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E1D89C-4773-4A0C-99F9-F29AA1628430}" type="datetimeFigureOut">
              <a:rPr lang="en-US" smtClean="0"/>
              <a:t>12/1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ED02A2-DBF3-43CE-9BE3-A24CFF2C8C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76789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E1D89C-4773-4A0C-99F9-F29AA1628430}" type="datetimeFigureOut">
              <a:rPr lang="en-US" smtClean="0"/>
              <a:t>12/1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ED02A2-DBF3-43CE-9BE3-A24CFF2C8C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01792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854575" y="718604"/>
            <a:ext cx="19379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TTCAGGTGGTCTAGACCGA[CGG]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2337171" y="718604"/>
            <a:ext cx="5499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gRNA1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703232" y="935553"/>
            <a:ext cx="11789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ossible off-target 1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703232" y="1152502"/>
            <a:ext cx="11644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ossible off-target 2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703232" y="1369451"/>
            <a:ext cx="12147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Possible off-target 3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2867275" y="1369451"/>
            <a:ext cx="19379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T</a:t>
            </a:r>
            <a:r>
              <a:rPr lang="en-US" sz="8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GGTGGT - TAG</a:t>
            </a:r>
            <a:r>
              <a:rPr lang="en-US" sz="8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CGA[AGG]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2867275" y="935553"/>
            <a:ext cx="19379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TCAGGTGGT</a:t>
            </a:r>
            <a:r>
              <a:rPr lang="en-US" sz="8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AGAC - - A[TGG]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2867275" y="1152502"/>
            <a:ext cx="19379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TCAG</a:t>
            </a:r>
            <a:r>
              <a:rPr lang="en-US" sz="800" b="1" dirty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 - - TCTAGACCGA[TGG]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646054" y="2000326"/>
            <a:ext cx="56578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ossible gRNA1 off-target sites selected for downstream Sanger sequencing to assess the specificity of editing events. Nucleotides denoted in red are different from those in the gRNA1 target site.</a:t>
            </a:r>
          </a:p>
        </p:txBody>
      </p:sp>
    </p:spTree>
    <p:extLst>
      <p:ext uri="{BB962C8B-B14F-4D97-AF65-F5344CB8AC3E}">
        <p14:creationId xmlns:p14="http://schemas.microsoft.com/office/powerpoint/2010/main" val="2147441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l="9545" t="12846" b="17592"/>
          <a:stretch/>
        </p:blipFill>
        <p:spPr>
          <a:xfrm>
            <a:off x="1320729" y="958468"/>
            <a:ext cx="4122793" cy="2642072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451688" y="5455418"/>
            <a:ext cx="6004193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profile of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sSPL8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lleles. Expression profiles were screened using the freely availabl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gumeI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atabase with the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. sativa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ltivated at the diploid level (CADL) genome (v1.0). For expression evaluations in different tissues, the F56 alfalfa genotype was utilized in the experiment. Bars indicate 95% confidence intervals in each case.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067337" y="906396"/>
            <a:ext cx="4406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067337" y="1404908"/>
            <a:ext cx="4406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067337" y="1914439"/>
            <a:ext cx="4406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067337" y="2422460"/>
            <a:ext cx="4406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067337" y="2920283"/>
            <a:ext cx="4406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067337" y="3429712"/>
            <a:ext cx="4406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0" name="TextBox 9"/>
          <p:cNvSpPr txBox="1"/>
          <p:nvPr/>
        </p:nvSpPr>
        <p:spPr>
          <a:xfrm rot="5400000">
            <a:off x="1417946" y="3677836"/>
            <a:ext cx="5783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Root</a:t>
            </a:r>
          </a:p>
        </p:txBody>
      </p:sp>
      <p:sp>
        <p:nvSpPr>
          <p:cNvPr id="11" name="TextBox 10"/>
          <p:cNvSpPr txBox="1"/>
          <p:nvPr/>
        </p:nvSpPr>
        <p:spPr>
          <a:xfrm rot="5400000">
            <a:off x="2058893" y="3730161"/>
            <a:ext cx="6830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odule</a:t>
            </a:r>
          </a:p>
        </p:txBody>
      </p:sp>
      <p:sp>
        <p:nvSpPr>
          <p:cNvPr id="12" name="TextBox 11"/>
          <p:cNvSpPr txBox="1"/>
          <p:nvPr/>
        </p:nvSpPr>
        <p:spPr>
          <a:xfrm rot="5400000">
            <a:off x="2687633" y="3739667"/>
            <a:ext cx="7020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eaf</a:t>
            </a:r>
          </a:p>
        </p:txBody>
      </p:sp>
      <p:sp>
        <p:nvSpPr>
          <p:cNvPr id="13" name="TextBox 12"/>
          <p:cNvSpPr txBox="1"/>
          <p:nvPr/>
        </p:nvSpPr>
        <p:spPr>
          <a:xfrm rot="5400000">
            <a:off x="3377192" y="3723417"/>
            <a:ext cx="6695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lower</a:t>
            </a:r>
          </a:p>
        </p:txBody>
      </p:sp>
      <p:sp>
        <p:nvSpPr>
          <p:cNvPr id="14" name="TextBox 13"/>
          <p:cNvSpPr txBox="1"/>
          <p:nvPr/>
        </p:nvSpPr>
        <p:spPr>
          <a:xfrm rot="5400000">
            <a:off x="3553864" y="4228791"/>
            <a:ext cx="16803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re-elongated stem</a:t>
            </a:r>
          </a:p>
        </p:txBody>
      </p:sp>
      <p:sp>
        <p:nvSpPr>
          <p:cNvPr id="15" name="TextBox 14"/>
          <p:cNvSpPr txBox="1"/>
          <p:nvPr/>
        </p:nvSpPr>
        <p:spPr>
          <a:xfrm rot="5400000">
            <a:off x="4267701" y="4164789"/>
            <a:ext cx="15522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longated stem</a:t>
            </a:r>
          </a:p>
        </p:txBody>
      </p:sp>
      <p:pic>
        <p:nvPicPr>
          <p:cNvPr id="16" name="Picture 15"/>
          <p:cNvPicPr>
            <a:picLocks noChangeAspect="1"/>
          </p:cNvPicPr>
          <p:nvPr/>
        </p:nvPicPr>
        <p:blipFill rotWithShape="1">
          <a:blip r:embed="rId2"/>
          <a:srcRect l="28231" t="91009" r="67098" b="2112"/>
          <a:stretch/>
        </p:blipFill>
        <p:spPr>
          <a:xfrm>
            <a:off x="2059903" y="5063472"/>
            <a:ext cx="242371" cy="297454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2232055" y="5058642"/>
            <a:ext cx="1602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SAD_231217</a:t>
            </a:r>
          </a:p>
        </p:txBody>
      </p:sp>
      <p:pic>
        <p:nvPicPr>
          <p:cNvPr id="18" name="Picture 17"/>
          <p:cNvPicPr>
            <a:picLocks noChangeAspect="1"/>
          </p:cNvPicPr>
          <p:nvPr/>
        </p:nvPicPr>
        <p:blipFill rotWithShape="1">
          <a:blip r:embed="rId2"/>
          <a:srcRect l="50349" t="91736" r="44980" b="3423"/>
          <a:stretch/>
        </p:blipFill>
        <p:spPr>
          <a:xfrm>
            <a:off x="3425712" y="5100473"/>
            <a:ext cx="242371" cy="209320"/>
          </a:xfrm>
          <a:prstGeom prst="rect">
            <a:avLst/>
          </a:prstGeom>
        </p:spPr>
      </p:pic>
      <p:sp>
        <p:nvSpPr>
          <p:cNvPr id="19" name="TextBox 18"/>
          <p:cNvSpPr txBox="1"/>
          <p:nvPr/>
        </p:nvSpPr>
        <p:spPr>
          <a:xfrm>
            <a:off x="3580145" y="5058642"/>
            <a:ext cx="16022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MSAD_231229</a:t>
            </a:r>
          </a:p>
        </p:txBody>
      </p:sp>
    </p:spTree>
    <p:extLst>
      <p:ext uri="{BB962C8B-B14F-4D97-AF65-F5344CB8AC3E}">
        <p14:creationId xmlns:p14="http://schemas.microsoft.com/office/powerpoint/2010/main" val="29504681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2"/>
          <a:srcRect l="4328" b="6362"/>
          <a:stretch/>
        </p:blipFill>
        <p:spPr>
          <a:xfrm>
            <a:off x="661012" y="540884"/>
            <a:ext cx="2853972" cy="1783676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/>
          <a:srcRect l="4979" b="6398"/>
          <a:stretch/>
        </p:blipFill>
        <p:spPr>
          <a:xfrm>
            <a:off x="3756752" y="551543"/>
            <a:ext cx="2699838" cy="1773016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41524" y="400050"/>
            <a:ext cx="39591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5" name="Rectangle 4"/>
          <p:cNvSpPr/>
          <p:nvPr/>
        </p:nvSpPr>
        <p:spPr>
          <a:xfrm>
            <a:off x="397134" y="2691869"/>
            <a:ext cx="6235700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oot characteristics of SPL8-gRNA1 and EV control genotypes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-B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aphs display root length and root dry weight (DW) for 10 biological replicates of SPL8-gRNA1-1 (gRNA1-1) 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and -2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gRNA1-2) genotypes, respectively, along with 30 biological replicates of EV controls (10 from each of 3 independent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ansformant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For all graphs, each block represents the mean of biological replicates, while bars denote standard errors. Asterisks denote means that are significantly different from EV controls as determined by 2-tailed student’s t-tests assuming unequal variance (**, P ≤ 0.01). 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1200" dirty="0"/>
          </a:p>
        </p:txBody>
      </p:sp>
      <p:sp>
        <p:nvSpPr>
          <p:cNvPr id="6" name="TextBox 5"/>
          <p:cNvSpPr txBox="1"/>
          <p:nvPr/>
        </p:nvSpPr>
        <p:spPr>
          <a:xfrm>
            <a:off x="3429047" y="400050"/>
            <a:ext cx="5260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090972" y="2270736"/>
            <a:ext cx="23931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EV                      gRNA1-1               gRNA1-2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174749" y="2270736"/>
            <a:ext cx="23931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EV                   gRNA1-1              gRNA1-2</a:t>
            </a:r>
          </a:p>
        </p:txBody>
      </p:sp>
      <p:sp>
        <p:nvSpPr>
          <p:cNvPr id="9" name="TextBox 8"/>
          <p:cNvSpPr txBox="1"/>
          <p:nvPr/>
        </p:nvSpPr>
        <p:spPr>
          <a:xfrm rot="16200000">
            <a:off x="7956" y="1240030"/>
            <a:ext cx="11347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Root length (cm)</a:t>
            </a:r>
          </a:p>
        </p:txBody>
      </p:sp>
      <p:sp>
        <p:nvSpPr>
          <p:cNvPr id="10" name="TextBox 9"/>
          <p:cNvSpPr txBox="1"/>
          <p:nvPr/>
        </p:nvSpPr>
        <p:spPr>
          <a:xfrm rot="16200000">
            <a:off x="3110670" y="1136696"/>
            <a:ext cx="113473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Root DW (g)</a:t>
            </a:r>
          </a:p>
        </p:txBody>
      </p:sp>
    </p:spTree>
    <p:extLst>
      <p:ext uri="{BB962C8B-B14F-4D97-AF65-F5344CB8AC3E}">
        <p14:creationId xmlns:p14="http://schemas.microsoft.com/office/powerpoint/2010/main" val="119485516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8485" y="393052"/>
            <a:ext cx="5490464" cy="36576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 rot="5400000">
            <a:off x="974316" y="4222386"/>
            <a:ext cx="107171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SPL8-gRNA1-1 (F)</a:t>
            </a:r>
          </a:p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</a:p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AC Blue J (M)</a:t>
            </a:r>
          </a:p>
        </p:txBody>
      </p:sp>
      <p:sp>
        <p:nvSpPr>
          <p:cNvPr id="4" name="TextBox 3"/>
          <p:cNvSpPr txBox="1"/>
          <p:nvPr/>
        </p:nvSpPr>
        <p:spPr>
          <a:xfrm rot="5400000">
            <a:off x="1764891" y="4219211"/>
            <a:ext cx="107171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SPL8-gRNA1-2 (F)</a:t>
            </a:r>
          </a:p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</a:p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AC Blue J (M)</a:t>
            </a:r>
          </a:p>
        </p:txBody>
      </p:sp>
      <p:sp>
        <p:nvSpPr>
          <p:cNvPr id="5" name="TextBox 4"/>
          <p:cNvSpPr txBox="1"/>
          <p:nvPr/>
        </p:nvSpPr>
        <p:spPr>
          <a:xfrm rot="5400000">
            <a:off x="2905666" y="4228735"/>
            <a:ext cx="130791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AC Blue J (F)</a:t>
            </a:r>
          </a:p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</a:p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SPL8-gRNA1-1 (M)</a:t>
            </a:r>
          </a:p>
        </p:txBody>
      </p:sp>
      <p:sp>
        <p:nvSpPr>
          <p:cNvPr id="6" name="TextBox 5"/>
          <p:cNvSpPr txBox="1"/>
          <p:nvPr/>
        </p:nvSpPr>
        <p:spPr>
          <a:xfrm rot="5400000">
            <a:off x="4234391" y="4225561"/>
            <a:ext cx="130791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AC Blue J (F)</a:t>
            </a:r>
          </a:p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X</a:t>
            </a:r>
          </a:p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SPL8-gRNA1-2 (M)</a:t>
            </a:r>
          </a:p>
        </p:txBody>
      </p:sp>
      <p:sp>
        <p:nvSpPr>
          <p:cNvPr id="7" name="TextBox 6"/>
          <p:cNvSpPr txBox="1"/>
          <p:nvPr/>
        </p:nvSpPr>
        <p:spPr>
          <a:xfrm rot="5400000">
            <a:off x="4932552" y="4148646"/>
            <a:ext cx="13079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AC Blue J</a:t>
            </a:r>
          </a:p>
        </p:txBody>
      </p:sp>
      <p:sp>
        <p:nvSpPr>
          <p:cNvPr id="8" name="TextBox 7"/>
          <p:cNvSpPr txBox="1"/>
          <p:nvPr/>
        </p:nvSpPr>
        <p:spPr>
          <a:xfrm rot="5400000">
            <a:off x="5219132" y="4256596"/>
            <a:ext cx="13079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SPL8-gRNA1-1</a:t>
            </a:r>
          </a:p>
        </p:txBody>
      </p:sp>
      <p:sp>
        <p:nvSpPr>
          <p:cNvPr id="9" name="TextBox 8"/>
          <p:cNvSpPr txBox="1"/>
          <p:nvPr/>
        </p:nvSpPr>
        <p:spPr>
          <a:xfrm rot="5400000">
            <a:off x="5337437" y="4256596"/>
            <a:ext cx="13079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SPL8-gRNA1-2</a:t>
            </a:r>
          </a:p>
        </p:txBody>
      </p:sp>
      <p:cxnSp>
        <p:nvCxnSpPr>
          <p:cNvPr id="10" name="Straight Connector 9"/>
          <p:cNvCxnSpPr/>
          <p:nvPr/>
        </p:nvCxnSpPr>
        <p:spPr>
          <a:xfrm>
            <a:off x="1111045" y="3952285"/>
            <a:ext cx="82591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1963999" y="3952285"/>
            <a:ext cx="67665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2667699" y="3952285"/>
            <a:ext cx="1700784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>
            <a:off x="4395527" y="3952285"/>
            <a:ext cx="82591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5248480" y="3952285"/>
            <a:ext cx="585216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/>
          <p:cNvSpPr txBox="1"/>
          <p:nvPr/>
        </p:nvSpPr>
        <p:spPr>
          <a:xfrm>
            <a:off x="816077" y="5348748"/>
            <a:ext cx="541757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4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editing frequency in F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ants as determined by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dPCR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F</a:t>
            </a:r>
            <a:r>
              <a:rPr lang="en-US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ants were generated through reciprocal crosses between SPL8-gRNA1-1 and AC Blue J genotypes, as well as SPL8-gRNA1-2 and AC Blue J genotypes. Each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lour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presents plants derived from distinct seeds produced from each type of cross. Parental AC Blue J genotypes, as well as SPL8-gRNA1-1 and SPL8-gRNA1-2 were assessed as controls. F, female parent; M, male parent.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35657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12</Words>
  <Application>Microsoft Office PowerPoint</Application>
  <PresentationFormat>Letter Paper (8.5x11 in)</PresentationFormat>
  <Paragraphs>47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inger, Stacy</dc:creator>
  <cp:lastModifiedBy>Hima Bhatt</cp:lastModifiedBy>
  <cp:revision>7</cp:revision>
  <dcterms:created xsi:type="dcterms:W3CDTF">2020-11-23T22:06:22Z</dcterms:created>
  <dcterms:modified xsi:type="dcterms:W3CDTF">2021-12-13T09:19:11Z</dcterms:modified>
</cp:coreProperties>
</file>